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6" r:id="rId2"/>
    <p:sldId id="257" r:id="rId3"/>
    <p:sldId id="258" r:id="rId4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6"/>
    <p:restoredTop sz="72371" autoAdjust="0"/>
  </p:normalViewPr>
  <p:slideViewPr>
    <p:cSldViewPr snapToGrid="0">
      <p:cViewPr varScale="1">
        <p:scale>
          <a:sx n="80" d="100"/>
          <a:sy n="80" d="100"/>
        </p:scale>
        <p:origin x="406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notesMaster" Target="notesMasters/notesMaster1.xml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7BAB46E-73D2-4C1E-A41D-9851DBEBED51}" type="datetimeFigureOut">
              <a:rPr lang="en-US" smtClean="0"/>
              <a:t>8/1/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CD167F8-B53E-4B40-93CB-5EDD68D9FD9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75672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19, 3, 2, 4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CD167F8-B53E-4B40-93CB-5EDD68D9FD9E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558419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13, 4, 4, 8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CD167F8-B53E-4B40-93CB-5EDD68D9FD9E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430167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059A0-0DC9-44D2-AE38-A23BAD8B06EB}" type="datetimeFigureOut">
              <a:rPr lang="en-US" smtClean="0"/>
              <a:t>8/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9DCC21-CA34-4C90-AE3B-C31A218026A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97110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059A0-0DC9-44D2-AE38-A23BAD8B06EB}" type="datetimeFigureOut">
              <a:rPr lang="en-US" smtClean="0"/>
              <a:t>8/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9DCC21-CA34-4C90-AE3B-C31A218026A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51559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761060" y="649818"/>
            <a:ext cx="831354" cy="1033144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65212" y="649818"/>
            <a:ext cx="2410122" cy="1033144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059A0-0DC9-44D2-AE38-A23BAD8B06EB}" type="datetimeFigureOut">
              <a:rPr lang="en-US" smtClean="0"/>
              <a:t>8/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9DCC21-CA34-4C90-AE3B-C31A218026A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38750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059A0-0DC9-44D2-AE38-A23BAD8B06EB}" type="datetimeFigureOut">
              <a:rPr lang="en-US" smtClean="0"/>
              <a:t>8/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9DCC21-CA34-4C90-AE3B-C31A218026A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157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2"/>
            <a:ext cx="5915025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5"/>
            <a:ext cx="5915025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059A0-0DC9-44D2-AE38-A23BAD8B06EB}" type="datetimeFigureOut">
              <a:rPr lang="en-US" smtClean="0"/>
              <a:t>8/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9DCC21-CA34-4C90-AE3B-C31A218026A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45699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65212" y="3244851"/>
            <a:ext cx="1620738" cy="773641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971675" y="3244851"/>
            <a:ext cx="1620739" cy="773641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059A0-0DC9-44D2-AE38-A23BAD8B06EB}" type="datetimeFigureOut">
              <a:rPr lang="en-US" smtClean="0"/>
              <a:t>8/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9DCC21-CA34-4C90-AE3B-C31A218026A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51691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4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059A0-0DC9-44D2-AE38-A23BAD8B06EB}" type="datetimeFigureOut">
              <a:rPr lang="en-US" smtClean="0"/>
              <a:t>8/1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9DCC21-CA34-4C90-AE3B-C31A218026A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93446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059A0-0DC9-44D2-AE38-A23BAD8B06EB}" type="datetimeFigureOut">
              <a:rPr lang="en-US" smtClean="0"/>
              <a:t>8/1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9DCC21-CA34-4C90-AE3B-C31A218026A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85771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059A0-0DC9-44D2-AE38-A23BAD8B06EB}" type="datetimeFigureOut">
              <a:rPr lang="en-US" smtClean="0"/>
              <a:t>8/1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9DCC21-CA34-4C90-AE3B-C31A218026A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56167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059A0-0DC9-44D2-AE38-A23BAD8B06EB}" type="datetimeFigureOut">
              <a:rPr lang="en-US" smtClean="0"/>
              <a:t>8/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9DCC21-CA34-4C90-AE3B-C31A218026A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75214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059A0-0DC9-44D2-AE38-A23BAD8B06EB}" type="datetimeFigureOut">
              <a:rPr lang="en-US" smtClean="0"/>
              <a:t>8/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9DCC21-CA34-4C90-AE3B-C31A218026A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44699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4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4059A0-0DC9-44D2-AE38-A23BAD8B06EB}" type="datetimeFigureOut">
              <a:rPr lang="en-US" smtClean="0"/>
              <a:t>8/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4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9DCC21-CA34-4C90-AE3B-C31A218026A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70682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4" Type="http://schemas.openxmlformats.org/officeDocument/2006/relationships/image" Target="../media/image2.emf"/><Relationship Id="rId5" Type="http://schemas.openxmlformats.org/officeDocument/2006/relationships/image" Target="../media/image3.emf"/><Relationship Id="rId6" Type="http://schemas.openxmlformats.org/officeDocument/2006/relationships/image" Target="../media/image4.emf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4" Type="http://schemas.openxmlformats.org/officeDocument/2006/relationships/image" Target="../media/image6.emf"/><Relationship Id="rId5" Type="http://schemas.openxmlformats.org/officeDocument/2006/relationships/image" Target="../media/image7.emf"/><Relationship Id="rId6" Type="http://schemas.openxmlformats.org/officeDocument/2006/relationships/image" Target="../media/image8.emf"/><Relationship Id="rId7" Type="http://schemas.openxmlformats.org/officeDocument/2006/relationships/image" Target="../media/image9.emf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55798" y="36442"/>
            <a:ext cx="6802202" cy="9107558"/>
            <a:chOff x="55798" y="36442"/>
            <a:chExt cx="6802202" cy="9107558"/>
          </a:xfrm>
        </p:grpSpPr>
        <p:sp>
          <p:nvSpPr>
            <p:cNvPr id="6" name="Rectangle 5"/>
            <p:cNvSpPr/>
            <p:nvPr/>
          </p:nvSpPr>
          <p:spPr>
            <a:xfrm>
              <a:off x="274320" y="405774"/>
              <a:ext cx="6583680" cy="873822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>
                <a:lnSpc>
                  <a:spcPct val="107000"/>
                </a:lnSpc>
              </a:pPr>
              <a:r>
                <a:rPr lang="en-US" sz="900" b="1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BW208 </a:t>
              </a:r>
              <a:r>
                <a:rPr lang="en-US" sz="900" b="1" dirty="0" err="1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wt</a:t>
              </a:r>
              <a:r>
                <a:rPr lang="en-US" sz="900" b="1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, group 1</a:t>
              </a:r>
              <a:endParaRPr lang="en-US" sz="9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>
                <a:lnSpc>
                  <a:spcPct val="107000"/>
                </a:lnSpc>
              </a:pPr>
              <a:r>
                <a:rPr lang="en-US" sz="900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TGAAGACCTTACTCATCCAAACAATCCTCGTGATGGCAATAACCATCGCCACCGCCAATATGCAGGTCGACCCTAGCGGCCAAGTACCATGGCCACAACAACAACCATTCCCGCAGCCTCACCAACCATTCTCCCAGCAACCGCAACAAACATTTCCCCAACCCCAACAAACATTCCCCCATCAACCACAACAACAATTTTCCCAGCCTCAGCAACCACAACAACAATTTATCCAGCCCCAACAACCATTCCCCCAACAACCACAACAAACATATCCCCAGCGACCACAACAACCATTCCCCCAGACTCAACAACCC</a:t>
              </a:r>
              <a:r>
                <a:rPr lang="en-US" sz="900" u="sng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A</a:t>
              </a:r>
              <a:r>
                <a:rPr lang="en-US" sz="900" dirty="0" smtClean="0">
                  <a:solidFill>
                    <a:srgbClr val="FFFFFF"/>
                  </a:solidFill>
                  <a:effectLst/>
                  <a:highlight>
                    <a:srgbClr val="0000FF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ACCATTTCC</a:t>
              </a:r>
              <a:r>
                <a:rPr lang="en-US" sz="900" dirty="0" smtClean="0">
                  <a:effectLst/>
                  <a:highlight>
                    <a:srgbClr val="FF0000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</a:t>
              </a:r>
              <a:r>
                <a:rPr lang="en-US" sz="900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GTCCCAGCAACCACAACAACCTTTTCCCCAGCCCCAACAACAATTCCCGCAGCCCCAACAACCACAACAATCATTCCCCCAACAACAACCATCGTTGATTCAACAATCTCTACAACAACAGTTGAACCCATGCAAGAATTTCCTCTTGCAACAATGCAAACCTGTGTCCTTGGTGTCATCCCTCTGGTCAATGATCTTGCCACGAAGCGATTGCCAGGTGATGCGGCAACAATGTTGCCAACAACTAGCACAAATTCCTCAGCAACTCCAGTGTGCAGCCATCCATAGCATCGTGCATTCCATCATCATGCAGCAAGAACAACAAGAACAACGACAGGGTGTGCAAATCCTGGTGCCACTGTCTCAACAGCAACAGGTAGGTCAAGGTACTCTCGTCCAAGGTCAGGGCATCATCCAACCTCAACAACCAGCTCAATTGGAGGTGATTAGGTCATTGGTGTTGCAAACTCTTGCAACCATGTGCAACGTGTATGT</a:t>
              </a:r>
            </a:p>
            <a:p>
              <a:pPr>
                <a:lnSpc>
                  <a:spcPct val="107000"/>
                </a:lnSpc>
              </a:pPr>
              <a:r>
                <a:rPr lang="en-US" sz="900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 </a:t>
              </a:r>
            </a:p>
            <a:p>
              <a:pPr>
                <a:lnSpc>
                  <a:spcPct val="107000"/>
                </a:lnSpc>
              </a:pPr>
              <a:r>
                <a:rPr lang="en-US" sz="900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 </a:t>
              </a:r>
            </a:p>
            <a:p>
              <a:pPr>
                <a:lnSpc>
                  <a:spcPct val="107000"/>
                </a:lnSpc>
              </a:pPr>
              <a:r>
                <a:rPr lang="en-US" sz="900" b="1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BW208 </a:t>
              </a:r>
              <a:r>
                <a:rPr lang="en-US" sz="900" b="1" dirty="0" err="1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wt</a:t>
              </a:r>
              <a:r>
                <a:rPr lang="en-US" sz="900" b="1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, group 2</a:t>
              </a:r>
              <a:endParaRPr lang="en-US" sz="9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>
                <a:lnSpc>
                  <a:spcPct val="107000"/>
                </a:lnSpc>
              </a:pPr>
              <a:r>
                <a:rPr lang="en-US" sz="900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TGAAGACCTTACTCATCCTAACAATCCTTGCGATGGCAACAACAATCGCCACTGCCAATATGCAGGTCGACCCTAGCAGCCGAGTACAATGGCCACAAGAACAACCACCCCCCCAGTCCCAACAACCATTCTCCCAGCAACCACAACAAATATTTCCCCAACCCCAACAAACATTCCCCCATCAACCACAACAAGCATTTCTCCAACCTCAACAAACATTCCCCCGTCGACCACAACAACAATTTCCCCAGCCCCAGCAACCA</a:t>
              </a:r>
              <a:r>
                <a:rPr lang="en-US" sz="900" u="sng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A</a:t>
              </a:r>
              <a:r>
                <a:rPr lang="en-US" sz="900" dirty="0" smtClean="0">
                  <a:solidFill>
                    <a:srgbClr val="FFFFFF"/>
                  </a:solidFill>
                  <a:effectLst/>
                  <a:highlight>
                    <a:srgbClr val="0000FF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ACCATTTCC</a:t>
              </a:r>
              <a:r>
                <a:rPr lang="en-US" sz="900" dirty="0" smtClean="0">
                  <a:effectLst/>
                  <a:highlight>
                    <a:srgbClr val="FF0000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T</a:t>
              </a:r>
              <a:r>
                <a:rPr lang="en-US" sz="900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GCCCCAACAACCC</a:t>
              </a:r>
              <a:r>
                <a:rPr lang="en-US" sz="9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ACTACCATTTCCCCAACAAC</a:t>
              </a:r>
              <a:r>
                <a:rPr lang="en-US" sz="900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CAACAACCATTCCCCCAGCCTCAACAACCC</a:t>
              </a:r>
              <a:r>
                <a:rPr lang="en-US" sz="900" u="sng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A</a:t>
              </a:r>
              <a:r>
                <a:rPr lang="en-US" sz="900" dirty="0" smtClean="0">
                  <a:solidFill>
                    <a:srgbClr val="FFFFFF"/>
                  </a:solidFill>
                  <a:effectLst/>
                  <a:highlight>
                    <a:srgbClr val="0000FF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ACCATTTCC</a:t>
              </a:r>
              <a:r>
                <a:rPr lang="en-US" sz="900" dirty="0" smtClean="0">
                  <a:effectLst/>
                  <a:highlight>
                    <a:srgbClr val="FF0000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</a:t>
              </a:r>
              <a:r>
                <a:rPr lang="en-US" sz="900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GTCACAGCAACCACAACAACCTTTTCCCCAGCCCCAACAACAATTTCCGCAGCCCCAACAACCACAACAATCATTCCCCCAACAACAACAATGGATGATTCAGTCATTTCTACAACAACAGATGAACCCCTGCAAGAATTTCCTCTTGCAGCAATGCAACCCTGTGTCATTGGTGTCATCTCTCGTGTCAATAATCTTGCCACGAAGTGATTGCCAGCTGATGCAGCAACAATGTTGCCAACAACTAGCACAAATTCCTCAACAACTCCAGTGCGCAGCCATCCACAACGTCGCGCATTCCATCATCATGCAGCAAGAACAACAACGAGGCGTGCAGATCCTGCGGCCACTATTTCAGCTCGCCCAGGGTCTGGGTATCATCCAACCTCAACAACCAGCTCAATTGGAGGGGATCAGGTCATTGGTATTGAAAACTCTTCCAACCATGTGCAACGTGTATGT</a:t>
              </a:r>
            </a:p>
            <a:p>
              <a:pPr>
                <a:lnSpc>
                  <a:spcPct val="107000"/>
                </a:lnSpc>
              </a:pPr>
              <a:r>
                <a:rPr lang="en-US" sz="900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 </a:t>
              </a:r>
            </a:p>
            <a:p>
              <a:pPr>
                <a:lnSpc>
                  <a:spcPct val="107000"/>
                </a:lnSpc>
              </a:pPr>
              <a:r>
                <a:rPr lang="en-US" sz="900" b="1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BW208 </a:t>
              </a:r>
              <a:r>
                <a:rPr lang="en-US" sz="900" b="1" dirty="0" err="1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wt</a:t>
              </a:r>
              <a:r>
                <a:rPr lang="en-US" sz="900" b="1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, group 3</a:t>
              </a:r>
              <a:endParaRPr lang="en-US" sz="9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>
                <a:lnSpc>
                  <a:spcPct val="107000"/>
                </a:lnSpc>
              </a:pPr>
              <a:r>
                <a:rPr lang="en-US" sz="900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TGAAGACCTTACTCATCCTGACAATCATTGCGGTGGCACTAACTACCACCACCGCCAATATACAGGTCGACCCTAGTGGCCAAGTACAATGGCCACAACAACAACAACCATTCCCCCAGCCCCAACAACCACAACAAATTTTTCCCCAACCCCAACAAACATTCCCCCATCAACCACAACAAGCATTTCCCCAACCCCAACAAACATTCCCCCATCAACCACAACAACAATTTCCCCAGCCCCAGCAACCA</a:t>
              </a:r>
              <a:r>
                <a:rPr lang="en-US" sz="900" u="sng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A</a:t>
              </a:r>
              <a:r>
                <a:rPr lang="en-US" sz="900" dirty="0" smtClean="0">
                  <a:solidFill>
                    <a:srgbClr val="FFFFFF"/>
                  </a:solidFill>
                  <a:effectLst/>
                  <a:highlight>
                    <a:srgbClr val="0000FF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ACCATTTCC</a:t>
              </a:r>
              <a:r>
                <a:rPr lang="en-US" sz="900" dirty="0" smtClean="0">
                  <a:effectLst/>
                  <a:highlight>
                    <a:srgbClr val="FF0000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</a:t>
              </a:r>
              <a:r>
                <a:rPr lang="en-US" sz="900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GCAACCACAACAACAATTTCCCCAGCCCCAACAACCA</a:t>
              </a:r>
              <a:r>
                <a:rPr lang="en-US" sz="900" u="sng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A</a:t>
              </a:r>
              <a:r>
                <a:rPr lang="en-US" sz="900" dirty="0" smtClean="0">
                  <a:solidFill>
                    <a:srgbClr val="FFFFFF"/>
                  </a:solidFill>
                  <a:effectLst/>
                  <a:highlight>
                    <a:srgbClr val="0000FF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ACCATTTCC</a:t>
              </a:r>
              <a:r>
                <a:rPr lang="en-US" sz="900" dirty="0" smtClean="0">
                  <a:effectLst/>
                  <a:highlight>
                    <a:srgbClr val="FF0000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</a:t>
              </a:r>
              <a:r>
                <a:rPr lang="en-US" sz="900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GCAACCACAACAACAATTTCCCCAGCCCCAACAACCA</a:t>
              </a:r>
              <a:r>
                <a:rPr lang="en-US" sz="900" u="sng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A</a:t>
              </a:r>
              <a:r>
                <a:rPr lang="en-US" sz="900" dirty="0" smtClean="0">
                  <a:solidFill>
                    <a:srgbClr val="FFFFFF"/>
                  </a:solidFill>
                  <a:effectLst/>
                  <a:highlight>
                    <a:srgbClr val="0000FF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ACCATTTCC</a:t>
              </a:r>
              <a:r>
                <a:rPr lang="en-US" sz="900" dirty="0" smtClean="0">
                  <a:effectLst/>
                  <a:highlight>
                    <a:srgbClr val="FF0000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</a:t>
              </a:r>
              <a:r>
                <a:rPr lang="en-US" sz="900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GCCCCAACAACCC</a:t>
              </a:r>
              <a:r>
                <a:rPr lang="en-US" sz="900" u="sng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A</a:t>
              </a:r>
              <a:r>
                <a:rPr lang="en-US" sz="900" dirty="0" smtClean="0">
                  <a:solidFill>
                    <a:schemeClr val="bg1"/>
                  </a:solidFill>
                  <a:effectLst/>
                  <a:highlight>
                    <a:srgbClr val="0000FF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</a:t>
              </a:r>
              <a:r>
                <a:rPr lang="en-US" sz="900" dirty="0" smtClean="0">
                  <a:effectLst/>
                  <a:highlight>
                    <a:srgbClr val="FF0000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T</a:t>
              </a:r>
              <a:r>
                <a:rPr lang="en-US" sz="900" dirty="0" smtClean="0">
                  <a:solidFill>
                    <a:schemeClr val="bg1"/>
                  </a:solidFill>
                  <a:effectLst/>
                  <a:highlight>
                    <a:srgbClr val="0000FF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CCATTTCCG</a:t>
              </a:r>
              <a:r>
                <a:rPr lang="en-US" sz="900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ACAACCACAACAACCATTCCCCCAGCCTCAACAACCC</a:t>
              </a:r>
              <a:r>
                <a:rPr lang="en-US" sz="900" u="sng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A</a:t>
              </a:r>
              <a:r>
                <a:rPr lang="en-US" sz="900" dirty="0" smtClean="0">
                  <a:solidFill>
                    <a:srgbClr val="FFFFFF"/>
                  </a:solidFill>
                  <a:effectLst/>
                  <a:highlight>
                    <a:srgbClr val="0000FF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ACCATTTCC</a:t>
              </a:r>
              <a:r>
                <a:rPr lang="en-US" sz="900" dirty="0" smtClean="0">
                  <a:effectLst/>
                  <a:highlight>
                    <a:srgbClr val="FF0000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</a:t>
              </a:r>
              <a:r>
                <a:rPr lang="en-US" sz="900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GTTACAGCAACCACAACAACCTTTACCCCAGCCCCAACAACCGCAACAACCATTCCCCCAGCAACAACAACCATTGATTCAGCCATACCTACAACAACAGATGAACCCCTGCAAGAATTACCTCTTGCAACAATGCAACCCTGTGTCATTGGTGTCATCCCTCGTGTCAATGATCTTGCCACGAAGTGATTGCAAGGTGATGCGGCAACAATGTTGCCAACAACTAGCACAGATTCCTCAGCAGCTCCAGTGCGCAGCCATCCATGGCGTCGTGCATTCCATCATCATGCAGCAAGAACGACAACAACAACAACAACAACAACAAGGCATACAGATCATGCGGCCACTATTTCAGCTCGTCCAGGGTCAGGGCATCATCCAACCTCAACAACCAGCTCAATTGGAGGTGATCAGGTCATTGGTATTGGGAACTCTTCCAACCATGTGCAACGTGTATGT</a:t>
              </a:r>
            </a:p>
            <a:p>
              <a:pPr>
                <a:lnSpc>
                  <a:spcPct val="107000"/>
                </a:lnSpc>
              </a:pPr>
              <a:r>
                <a:rPr lang="en-US" sz="900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 </a:t>
              </a:r>
            </a:p>
            <a:p>
              <a:pPr>
                <a:lnSpc>
                  <a:spcPct val="107000"/>
                </a:lnSpc>
              </a:pPr>
              <a:r>
                <a:rPr lang="en-US" sz="900" b="1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BW208 </a:t>
              </a:r>
              <a:r>
                <a:rPr lang="en-US" sz="900" b="1" dirty="0" err="1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wt</a:t>
              </a:r>
              <a:r>
                <a:rPr lang="en-US" sz="900" b="1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, group 4</a:t>
              </a:r>
              <a:endParaRPr lang="en-US" sz="9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>
                <a:lnSpc>
                  <a:spcPct val="107000"/>
                </a:lnSpc>
              </a:pPr>
              <a:r>
                <a:rPr lang="en-US" sz="900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TGAAGACCTTACTCATCCWAACAATCCTYGYGATGGCAATAACCATCGGCACCGCCAATATSCAGGTCGACCCTAGCRGCCAAGTACAATGGCYACAACAACAACYAGTCCCMCAGCYYCAMCARCCATTMTCCCAGCAACCACAACAAACATTTCCCCRACCYCAACAAACATTCCCCCATCAACCACAACAACAAKTTYCCCAGCCTCAGCAACCACAACAACMATTTCTCCAGCCCCGACAACCATTCCCCCAACAACCACAACAACCATATCCCCAGCAACCACAGCAACCGTTCCCCCAGACTCAACAACCC</a:t>
              </a:r>
              <a:r>
                <a:rPr lang="en-US" sz="900" u="sng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A</a:t>
              </a:r>
              <a:r>
                <a:rPr lang="en-US" sz="900" dirty="0" smtClean="0">
                  <a:solidFill>
                    <a:srgbClr val="FFFFFF"/>
                  </a:solidFill>
                  <a:effectLst/>
                  <a:highlight>
                    <a:srgbClr val="0000FF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ACCATTTCC</a:t>
              </a:r>
              <a:r>
                <a:rPr lang="en-US" sz="900" dirty="0" smtClean="0">
                  <a:effectLst/>
                  <a:highlight>
                    <a:srgbClr val="FF0000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</a:t>
              </a:r>
              <a:r>
                <a:rPr lang="en-US" sz="900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GTCCAAGCAACCACAACAACCTTTTCCCCAGCCCCAACAACCGCAACAATCATTCCCCCAACAACAACCATCGTTGATTCAACAATCTCTACAACAACAGTTGAACCCATGCAAGAATTTCCTCTTGCAGCAATGCAAACCTGTGTCCTTGGTGTCATCSCTCTGGTCAATCATCTTGCCACCAAGCGATTGCCAGGTGATGCGGCAACAATGTTGTCAACAACTAGCACAAATTCCTCAGCAACTCCAGTGTGCAGCCATCCATAGCGTCGTGCATTCCATCATCATGCAGCAAGAACAACAAGAACAACTACAGGGTGTGCAAATCCTGGTGCCACTGTCTCAACAGCAACAAGTGGGTCAAGGTATTCTCGTCCAGGGTCAAGGCATCATCCAACCTCAACAACCAGCTCAATTGGAGGTGATCAGGTCATTGGTGTTGCAAACTCTTCCAACCATGTGCAACGTGTATGT</a:t>
              </a:r>
            </a:p>
            <a:p>
              <a:pPr>
                <a:lnSpc>
                  <a:spcPct val="107000"/>
                </a:lnSpc>
              </a:pPr>
              <a:endParaRPr lang="en-US" sz="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>
                <a:lnSpc>
                  <a:spcPct val="107000"/>
                </a:lnSpc>
              </a:pPr>
              <a:r>
                <a:rPr lang="en-US" sz="900" b="1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BW208 </a:t>
              </a:r>
              <a:r>
                <a:rPr lang="en-US" sz="900" b="1" dirty="0" err="1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wt</a:t>
              </a:r>
              <a:r>
                <a:rPr lang="en-US" sz="900" b="1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, group 5</a:t>
              </a:r>
              <a:endParaRPr lang="en-US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r>
                <a:rPr lang="en-US" sz="9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TGAAGACCTTACTCATCCTGACAATCCTTGCGATGGCAATAACCATCGGCACCGCCAATATCCAGGTCGACCCTAGCGGCCAAGTACAATGGCTACAACAACAACTAGTCCCCCAGCTCCAACAGCCATTATCCCAGCAACCACAACAAACATTTCCCCAACCTCAACAAACATTCCCCCATCAACCACAACAACAAGTTCCCCAGCCTCAGCAACCA</a:t>
              </a:r>
              <a:r>
                <a:rPr lang="en-US" sz="900" u="sng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A</a:t>
              </a:r>
              <a:r>
                <a:rPr lang="en-US" sz="9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ACCATTTCTCCAGCCCCAACAACCATTCCCCCAACAACCACAACAACCATTCCCCCAGACTCAACAACCA</a:t>
              </a:r>
              <a:r>
                <a:rPr lang="en-US" sz="900" u="sng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A</a:t>
              </a:r>
              <a:r>
                <a:rPr lang="en-US" sz="900" dirty="0">
                  <a:solidFill>
                    <a:srgbClr val="FFFFFF"/>
                  </a:solidFill>
                  <a:highlight>
                    <a:srgbClr val="0000FF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ACCATTTCC</a:t>
              </a:r>
              <a:r>
                <a:rPr lang="en-US" sz="900" dirty="0">
                  <a:highlight>
                    <a:srgbClr val="FF0000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</a:t>
              </a:r>
              <a:r>
                <a:rPr lang="en-US" sz="9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GCAACCA</a:t>
              </a:r>
              <a:r>
                <a:rPr lang="en-US" sz="900" u="sng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A</a:t>
              </a:r>
              <a:r>
                <a:rPr lang="en-US" sz="900" dirty="0">
                  <a:solidFill>
                    <a:srgbClr val="FFFFFF"/>
                  </a:solidFill>
                  <a:highlight>
                    <a:srgbClr val="0000FF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ACCATTTCC</a:t>
              </a:r>
              <a:r>
                <a:rPr lang="en-US" sz="900" dirty="0">
                  <a:highlight>
                    <a:srgbClr val="FF0000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</a:t>
              </a:r>
              <a:r>
                <a:rPr lang="en-US" sz="9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GACTCAACAACCC</a:t>
              </a:r>
              <a:r>
                <a:rPr lang="en-US" sz="900" u="sng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A</a:t>
              </a:r>
              <a:r>
                <a:rPr lang="en-US" sz="900" dirty="0">
                  <a:solidFill>
                    <a:srgbClr val="FFFFFF"/>
                  </a:solidFill>
                  <a:highlight>
                    <a:srgbClr val="0000FF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ACCATTTCC</a:t>
              </a:r>
              <a:r>
                <a:rPr lang="en-US" sz="900" dirty="0">
                  <a:highlight>
                    <a:srgbClr val="FF0000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</a:t>
              </a:r>
              <a:r>
                <a:rPr lang="en-US" sz="9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ACAACCACAACAACCATTCCCCCAGACTCAACAACCC</a:t>
              </a:r>
              <a:r>
                <a:rPr lang="en-US" sz="900" u="sng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A</a:t>
              </a:r>
              <a:r>
                <a:rPr lang="en-US" sz="900" dirty="0">
                  <a:solidFill>
                    <a:srgbClr val="FFFFFF"/>
                  </a:solidFill>
                  <a:highlight>
                    <a:srgbClr val="0000FF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ACCATTTCC</a:t>
              </a:r>
              <a:r>
                <a:rPr lang="en-US" sz="900" dirty="0">
                  <a:highlight>
                    <a:srgbClr val="FF0000"/>
                  </a:highlight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</a:t>
              </a:r>
              <a:r>
                <a:rPr lang="en-US" sz="900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AGCTCCAGCAACCACAACAACCTTTTCCCCAGCCCCAACAACAATTGCCGCAGCCCCAACAACCGCAACAATCATTCCCCCAACAACAACGGCCATTCATTCAACCATCTCTACAACAACAGTTGAACCCATGCAAGAATATCCTCTTGCAACAATGCAAACCTGCGTCATTGGTGTCATCCCTCTGGTCAATAATCTGGCCACAAAGCGATTGCCAAGTGATGCGGCAACAATGCTGCCAACAACTAGCACAGATTCCTCAACAGCTCCAGTGCGCAGCCATCCATAGCGTCGTGCATTCCATCATCATGCAGCAGCAGCAGCAACAACAACAACAACAAGGCATGCATATCTTTCTGCCACTATCTCAGCAGCAACAGGTGGGTCAAGGTTCTCTAGTCCAAGGCCAGGGCATCATCCAACCACAACAACCAGCTCAATTGGAGGCGATCAGATCATTGGTGTTGCAAACTCTTCCATCCATGTGCAACGTGTATGT</a:t>
              </a:r>
              <a:endParaRPr lang="en-US" sz="9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US" sz="900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/>
              </a:r>
              <a:br>
                <a:rPr lang="en-US" sz="900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lang="en-US" sz="900" dirty="0" smtClean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 </a:t>
              </a:r>
              <a:endParaRPr lang="en-US" sz="9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" name="Rectangle 1"/>
            <p:cNvSpPr/>
            <p:nvPr/>
          </p:nvSpPr>
          <p:spPr>
            <a:xfrm>
              <a:off x="55798" y="36442"/>
              <a:ext cx="298480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b="1" dirty="0" smtClean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</a:t>
              </a:r>
              <a:endParaRPr 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31398110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/>
          <p:cNvGrpSpPr/>
          <p:nvPr/>
        </p:nvGrpSpPr>
        <p:grpSpPr>
          <a:xfrm>
            <a:off x="-23559" y="0"/>
            <a:ext cx="6819982" cy="6993418"/>
            <a:chOff x="-23559" y="0"/>
            <a:chExt cx="6819982" cy="6993418"/>
          </a:xfrm>
        </p:grpSpPr>
        <p:grpSp>
          <p:nvGrpSpPr>
            <p:cNvPr id="15" name="Group 14"/>
            <p:cNvGrpSpPr/>
            <p:nvPr/>
          </p:nvGrpSpPr>
          <p:grpSpPr>
            <a:xfrm>
              <a:off x="60343" y="3123201"/>
              <a:ext cx="6736079" cy="924512"/>
              <a:chOff x="60343" y="3384453"/>
              <a:chExt cx="6736079" cy="924512"/>
            </a:xfrm>
          </p:grpSpPr>
          <p:pic>
            <p:nvPicPr>
              <p:cNvPr id="14" name="Picture 13"/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44" b="50132"/>
              <a:stretch/>
            </p:blipFill>
            <p:spPr>
              <a:xfrm>
                <a:off x="63499" y="3384453"/>
                <a:ext cx="6732923" cy="400147"/>
              </a:xfrm>
              <a:prstGeom prst="rect">
                <a:avLst/>
              </a:prstGeom>
            </p:spPr>
          </p:pic>
          <p:pic>
            <p:nvPicPr>
              <p:cNvPr id="27" name="Picture 26"/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44" t="49077" r="73357"/>
              <a:stretch/>
            </p:blipFill>
            <p:spPr>
              <a:xfrm>
                <a:off x="60343" y="3900355"/>
                <a:ext cx="1711307" cy="408610"/>
              </a:xfrm>
              <a:prstGeom prst="rect">
                <a:avLst/>
              </a:prstGeom>
            </p:spPr>
          </p:pic>
        </p:grpSp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66" r="1556"/>
            <a:stretch/>
          </p:blipFill>
          <p:spPr>
            <a:xfrm>
              <a:off x="66695" y="886048"/>
              <a:ext cx="6637020" cy="1719155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11" r="1445"/>
            <a:stretch/>
          </p:blipFill>
          <p:spPr>
            <a:xfrm>
              <a:off x="50818" y="6433505"/>
              <a:ext cx="6614160" cy="559913"/>
            </a:xfrm>
            <a:prstGeom prst="rect">
              <a:avLst/>
            </a:prstGeom>
          </p:spPr>
        </p:pic>
        <p:grpSp>
          <p:nvGrpSpPr>
            <p:cNvPr id="10" name="Group 9"/>
            <p:cNvGrpSpPr/>
            <p:nvPr/>
          </p:nvGrpSpPr>
          <p:grpSpPr>
            <a:xfrm>
              <a:off x="60343" y="4566523"/>
              <a:ext cx="6736080" cy="1259475"/>
              <a:chOff x="121920" y="4513925"/>
              <a:chExt cx="6736080" cy="1259475"/>
            </a:xfrm>
          </p:grpSpPr>
          <p:pic>
            <p:nvPicPr>
              <p:cNvPr id="4" name="Picture 3"/>
              <p:cNvPicPr>
                <a:picLocks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78" b="51168"/>
              <a:stretch/>
            </p:blipFill>
            <p:spPr>
              <a:xfrm>
                <a:off x="121920" y="4513925"/>
                <a:ext cx="6736080" cy="472450"/>
              </a:xfrm>
              <a:prstGeom prst="rect">
                <a:avLst/>
              </a:prstGeom>
            </p:spPr>
          </p:pic>
          <p:pic>
            <p:nvPicPr>
              <p:cNvPr id="6" name="Picture 5"/>
              <p:cNvPicPr>
                <a:picLocks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77" t="48832" r="2333"/>
              <a:stretch/>
            </p:blipFill>
            <p:spPr>
              <a:xfrm>
                <a:off x="121920" y="5278349"/>
                <a:ext cx="6576060" cy="495051"/>
              </a:xfrm>
              <a:prstGeom prst="rect">
                <a:avLst/>
              </a:prstGeom>
            </p:spPr>
          </p:pic>
        </p:grpSp>
        <p:sp>
          <p:nvSpPr>
            <p:cNvPr id="7" name="Rectangle 6"/>
            <p:cNvSpPr/>
            <p:nvPr/>
          </p:nvSpPr>
          <p:spPr>
            <a:xfrm>
              <a:off x="79393" y="530996"/>
              <a:ext cx="108690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 smtClean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T544, Group </a:t>
              </a:r>
              <a:r>
                <a:rPr lang="en-US" sz="1200" b="1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1</a:t>
              </a:r>
              <a:endParaRPr lang="en-US" sz="1200" dirty="0"/>
            </a:p>
          </p:txBody>
        </p:sp>
        <p:sp>
          <p:nvSpPr>
            <p:cNvPr id="8" name="Rectangle 7"/>
            <p:cNvSpPr/>
            <p:nvPr/>
          </p:nvSpPr>
          <p:spPr>
            <a:xfrm>
              <a:off x="73042" y="2806357"/>
              <a:ext cx="108690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 smtClean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T544, Group 2</a:t>
              </a:r>
              <a:endParaRPr lang="en-US" sz="1200" dirty="0"/>
            </a:p>
          </p:txBody>
        </p:sp>
        <p:sp>
          <p:nvSpPr>
            <p:cNvPr id="9" name="Rectangle 8"/>
            <p:cNvSpPr/>
            <p:nvPr/>
          </p:nvSpPr>
          <p:spPr>
            <a:xfrm>
              <a:off x="76216" y="4344551"/>
              <a:ext cx="108690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 smtClean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T544, Group 3</a:t>
              </a:r>
              <a:endParaRPr lang="en-US" sz="1200" dirty="0"/>
            </a:p>
          </p:txBody>
        </p:sp>
        <p:sp>
          <p:nvSpPr>
            <p:cNvPr id="11" name="Rectangle 10"/>
            <p:cNvSpPr/>
            <p:nvPr/>
          </p:nvSpPr>
          <p:spPr>
            <a:xfrm>
              <a:off x="73041" y="6085570"/>
              <a:ext cx="108690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 smtClean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T544, Group 4</a:t>
              </a:r>
              <a:endParaRPr lang="en-US" sz="1200" dirty="0"/>
            </a:p>
          </p:txBody>
        </p:sp>
        <p:sp>
          <p:nvSpPr>
            <p:cNvPr id="12" name="Rectangle 11"/>
            <p:cNvSpPr/>
            <p:nvPr/>
          </p:nvSpPr>
          <p:spPr>
            <a:xfrm>
              <a:off x="-23559" y="0"/>
              <a:ext cx="308098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b="1" dirty="0">
                  <a:latin typeface="Calibri" panose="020F0502020204030204" pitchFamily="34" charset="0"/>
                  <a:cs typeface="Times New Roman" panose="02020603050405020304" pitchFamily="18" charset="0"/>
                </a:rPr>
                <a:t>b</a:t>
              </a:r>
              <a:endParaRPr lang="en-US" dirty="0"/>
            </a:p>
          </p:txBody>
        </p:sp>
        <p:cxnSp>
          <p:nvCxnSpPr>
            <p:cNvPr id="17" name="Straight Connector 16"/>
            <p:cNvCxnSpPr/>
            <p:nvPr/>
          </p:nvCxnSpPr>
          <p:spPr>
            <a:xfrm>
              <a:off x="1111491" y="3210110"/>
              <a:ext cx="14630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>
            <a:xfrm>
              <a:off x="6350970" y="3210110"/>
              <a:ext cx="14630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/>
            <p:cNvCxnSpPr/>
            <p:nvPr/>
          </p:nvCxnSpPr>
          <p:spPr>
            <a:xfrm>
              <a:off x="1053579" y="4799081"/>
              <a:ext cx="14630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/>
            <p:cNvCxnSpPr/>
            <p:nvPr/>
          </p:nvCxnSpPr>
          <p:spPr>
            <a:xfrm>
              <a:off x="3960830" y="4799081"/>
              <a:ext cx="14630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/>
            <p:cNvCxnSpPr/>
            <p:nvPr/>
          </p:nvCxnSpPr>
          <p:spPr>
            <a:xfrm>
              <a:off x="3179780" y="982731"/>
              <a:ext cx="14630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/>
            <p:cNvCxnSpPr/>
            <p:nvPr/>
          </p:nvCxnSpPr>
          <p:spPr>
            <a:xfrm>
              <a:off x="773130" y="5421381"/>
              <a:ext cx="14630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/>
          </p:nvCxnSpPr>
          <p:spPr>
            <a:xfrm>
              <a:off x="2386030" y="5421381"/>
              <a:ext cx="14630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/>
            <p:cNvCxnSpPr/>
            <p:nvPr/>
          </p:nvCxnSpPr>
          <p:spPr>
            <a:xfrm>
              <a:off x="5313126" y="5421381"/>
              <a:ext cx="14630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/>
            <p:cNvCxnSpPr/>
            <p:nvPr/>
          </p:nvCxnSpPr>
          <p:spPr>
            <a:xfrm>
              <a:off x="3213117" y="6536261"/>
              <a:ext cx="14630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1355938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" name="Group 32"/>
          <p:cNvGrpSpPr/>
          <p:nvPr/>
        </p:nvGrpSpPr>
        <p:grpSpPr>
          <a:xfrm>
            <a:off x="55798" y="36442"/>
            <a:ext cx="6460704" cy="7874401"/>
            <a:chOff x="55798" y="36442"/>
            <a:chExt cx="6460704" cy="7874401"/>
          </a:xfrm>
        </p:grpSpPr>
        <p:pic>
          <p:nvPicPr>
            <p:cNvPr id="21" name="Picture 20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51125"/>
            <a:stretch/>
          </p:blipFill>
          <p:spPr>
            <a:xfrm>
              <a:off x="152394" y="2157443"/>
              <a:ext cx="6343656" cy="461744"/>
            </a:xfrm>
            <a:prstGeom prst="rect">
              <a:avLst/>
            </a:prstGeom>
          </p:spPr>
        </p:pic>
        <p:sp>
          <p:nvSpPr>
            <p:cNvPr id="2" name="Rectangle 1"/>
            <p:cNvSpPr/>
            <p:nvPr/>
          </p:nvSpPr>
          <p:spPr>
            <a:xfrm>
              <a:off x="152396" y="304145"/>
              <a:ext cx="108690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 smtClean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T545, Group </a:t>
              </a:r>
              <a:r>
                <a:rPr lang="en-US" sz="1200" b="1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1</a:t>
              </a:r>
              <a:endParaRPr lang="en-US" sz="1200" dirty="0"/>
            </a:p>
          </p:txBody>
        </p:sp>
        <p:sp>
          <p:nvSpPr>
            <p:cNvPr id="3" name="Rectangle 2"/>
            <p:cNvSpPr/>
            <p:nvPr/>
          </p:nvSpPr>
          <p:spPr>
            <a:xfrm>
              <a:off x="152394" y="1880059"/>
              <a:ext cx="108690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 smtClean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T545, Group 2</a:t>
              </a:r>
              <a:endParaRPr lang="en-US" sz="1200" dirty="0"/>
            </a:p>
          </p:txBody>
        </p:sp>
        <p:sp>
          <p:nvSpPr>
            <p:cNvPr id="4" name="Rectangle 3"/>
            <p:cNvSpPr/>
            <p:nvPr/>
          </p:nvSpPr>
          <p:spPr>
            <a:xfrm>
              <a:off x="128696" y="3315389"/>
              <a:ext cx="108690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 smtClean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T545, Group 3</a:t>
              </a:r>
              <a:endParaRPr lang="en-US" sz="1200" dirty="0"/>
            </a:p>
          </p:txBody>
        </p:sp>
        <p:sp>
          <p:nvSpPr>
            <p:cNvPr id="5" name="Rectangle 4"/>
            <p:cNvSpPr/>
            <p:nvPr/>
          </p:nvSpPr>
          <p:spPr>
            <a:xfrm>
              <a:off x="152394" y="5390302"/>
              <a:ext cx="108690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 smtClean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T545, Group 4</a:t>
              </a:r>
              <a:endParaRPr lang="en-US" sz="1200" dirty="0"/>
            </a:p>
          </p:txBody>
        </p:sp>
        <p:sp>
          <p:nvSpPr>
            <p:cNvPr id="6" name="Rectangle 5"/>
            <p:cNvSpPr/>
            <p:nvPr/>
          </p:nvSpPr>
          <p:spPr>
            <a:xfrm>
              <a:off x="158748" y="6727404"/>
              <a:ext cx="108690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 smtClean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T545, Group 5</a:t>
              </a:r>
              <a:endParaRPr lang="en-US" sz="1200" dirty="0"/>
            </a:p>
          </p:txBody>
        </p:sp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480"/>
            <a:stretch/>
          </p:blipFill>
          <p:spPr>
            <a:xfrm>
              <a:off x="158749" y="667569"/>
              <a:ext cx="6337301" cy="1157819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503"/>
            <a:stretch/>
          </p:blipFill>
          <p:spPr>
            <a:xfrm>
              <a:off x="158749" y="5703150"/>
              <a:ext cx="6242051" cy="802230"/>
            </a:xfrm>
            <a:prstGeom prst="rect">
              <a:avLst/>
            </a:prstGeom>
          </p:spPr>
        </p:pic>
        <p:grpSp>
          <p:nvGrpSpPr>
            <p:cNvPr id="20" name="Group 19"/>
            <p:cNvGrpSpPr/>
            <p:nvPr/>
          </p:nvGrpSpPr>
          <p:grpSpPr>
            <a:xfrm>
              <a:off x="152394" y="3627945"/>
              <a:ext cx="6364108" cy="1649380"/>
              <a:chOff x="152395" y="3579845"/>
              <a:chExt cx="6364108" cy="1649380"/>
            </a:xfrm>
          </p:grpSpPr>
          <p:pic>
            <p:nvPicPr>
              <p:cNvPr id="9" name="Picture 8"/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66931"/>
              <a:stretch/>
            </p:blipFill>
            <p:spPr>
              <a:xfrm>
                <a:off x="158749" y="3579845"/>
                <a:ext cx="6357754" cy="481628"/>
              </a:xfrm>
              <a:prstGeom prst="rect">
                <a:avLst/>
              </a:prstGeom>
            </p:spPr>
          </p:pic>
          <p:pic>
            <p:nvPicPr>
              <p:cNvPr id="12" name="Picture 11"/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66712" r="68578"/>
              <a:stretch/>
            </p:blipFill>
            <p:spPr>
              <a:xfrm>
                <a:off x="152395" y="4758172"/>
                <a:ext cx="1997711" cy="471053"/>
              </a:xfrm>
              <a:prstGeom prst="rect">
                <a:avLst/>
              </a:prstGeom>
            </p:spPr>
          </p:pic>
          <p:pic>
            <p:nvPicPr>
              <p:cNvPr id="13" name="Picture 12"/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32734" b="34700"/>
              <a:stretch/>
            </p:blipFill>
            <p:spPr>
              <a:xfrm>
                <a:off x="152395" y="4174394"/>
                <a:ext cx="6357754" cy="471492"/>
              </a:xfrm>
              <a:prstGeom prst="rect">
                <a:avLst/>
              </a:prstGeom>
            </p:spPr>
          </p:pic>
        </p:grpSp>
        <p:grpSp>
          <p:nvGrpSpPr>
            <p:cNvPr id="19" name="Group 18"/>
            <p:cNvGrpSpPr/>
            <p:nvPr/>
          </p:nvGrpSpPr>
          <p:grpSpPr>
            <a:xfrm>
              <a:off x="158749" y="7082933"/>
              <a:ext cx="6242051" cy="827910"/>
              <a:chOff x="158749" y="7997335"/>
              <a:chExt cx="6242051" cy="827910"/>
            </a:xfrm>
          </p:grpSpPr>
          <p:pic>
            <p:nvPicPr>
              <p:cNvPr id="16" name="Picture 15"/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0275" b="24150"/>
              <a:stretch/>
            </p:blipFill>
            <p:spPr>
              <a:xfrm>
                <a:off x="158749" y="7997335"/>
                <a:ext cx="6242051" cy="339725"/>
              </a:xfrm>
              <a:prstGeom prst="rect">
                <a:avLst/>
              </a:prstGeom>
            </p:spPr>
          </p:pic>
          <p:pic>
            <p:nvPicPr>
              <p:cNvPr id="17" name="Picture 16"/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75072" r="16023"/>
              <a:stretch/>
            </p:blipFill>
            <p:spPr>
              <a:xfrm>
                <a:off x="158749" y="8494119"/>
                <a:ext cx="5241926" cy="331126"/>
              </a:xfrm>
              <a:prstGeom prst="rect">
                <a:avLst/>
              </a:prstGeom>
            </p:spPr>
          </p:pic>
        </p:grpSp>
        <p:sp>
          <p:nvSpPr>
            <p:cNvPr id="22" name="Rectangle 21"/>
            <p:cNvSpPr/>
            <p:nvPr/>
          </p:nvSpPr>
          <p:spPr>
            <a:xfrm>
              <a:off x="55798" y="36442"/>
              <a:ext cx="282450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dirty="0" smtClean="0"/>
                <a:t>c</a:t>
              </a:r>
              <a:endParaRPr lang="en-US" dirty="0"/>
            </a:p>
          </p:txBody>
        </p:sp>
        <p:cxnSp>
          <p:nvCxnSpPr>
            <p:cNvPr id="23" name="Straight Connector 22"/>
            <p:cNvCxnSpPr/>
            <p:nvPr/>
          </p:nvCxnSpPr>
          <p:spPr>
            <a:xfrm>
              <a:off x="1139493" y="2432850"/>
              <a:ext cx="14630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/>
          </p:nvCxnSpPr>
          <p:spPr>
            <a:xfrm>
              <a:off x="1076784" y="2905756"/>
              <a:ext cx="14630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/>
            <p:cNvCxnSpPr/>
            <p:nvPr/>
          </p:nvCxnSpPr>
          <p:spPr>
            <a:xfrm>
              <a:off x="1143096" y="3674743"/>
              <a:ext cx="14630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/>
            <p:cNvCxnSpPr/>
            <p:nvPr/>
          </p:nvCxnSpPr>
          <p:spPr>
            <a:xfrm>
              <a:off x="4248467" y="3674743"/>
              <a:ext cx="14630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/>
            <p:cNvCxnSpPr/>
            <p:nvPr/>
          </p:nvCxnSpPr>
          <p:spPr>
            <a:xfrm>
              <a:off x="3200717" y="902333"/>
              <a:ext cx="14630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/>
            <p:cNvCxnSpPr/>
            <p:nvPr/>
          </p:nvCxnSpPr>
          <p:spPr>
            <a:xfrm>
              <a:off x="672147" y="4838063"/>
              <a:ext cx="14630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/>
            <p:cNvCxnSpPr/>
            <p:nvPr/>
          </p:nvCxnSpPr>
          <p:spPr>
            <a:xfrm>
              <a:off x="1591627" y="4279892"/>
              <a:ext cx="14630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/>
            <p:cNvCxnSpPr/>
            <p:nvPr/>
          </p:nvCxnSpPr>
          <p:spPr>
            <a:xfrm>
              <a:off x="6409684" y="4273546"/>
              <a:ext cx="9144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/>
            <p:cNvCxnSpPr/>
            <p:nvPr/>
          </p:nvCxnSpPr>
          <p:spPr>
            <a:xfrm>
              <a:off x="3200717" y="5781673"/>
              <a:ext cx="14630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43"/>
            <p:cNvCxnSpPr/>
            <p:nvPr/>
          </p:nvCxnSpPr>
          <p:spPr>
            <a:xfrm>
              <a:off x="2690177" y="7176131"/>
              <a:ext cx="14630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Connector 44"/>
            <p:cNvCxnSpPr/>
            <p:nvPr/>
          </p:nvCxnSpPr>
          <p:spPr>
            <a:xfrm>
              <a:off x="4054157" y="7176131"/>
              <a:ext cx="14630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/>
            <p:cNvCxnSpPr/>
            <p:nvPr/>
          </p:nvCxnSpPr>
          <p:spPr>
            <a:xfrm>
              <a:off x="5761037" y="7174224"/>
              <a:ext cx="14630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/>
            <p:cNvCxnSpPr/>
            <p:nvPr/>
          </p:nvCxnSpPr>
          <p:spPr>
            <a:xfrm>
              <a:off x="3158045" y="7677144"/>
              <a:ext cx="14630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8" name="Picture 37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8703" r="62162"/>
            <a:stretch/>
          </p:blipFill>
          <p:spPr>
            <a:xfrm>
              <a:off x="158749" y="2710021"/>
              <a:ext cx="2400301" cy="484629"/>
            </a:xfrm>
            <a:prstGeom prst="rect">
              <a:avLst/>
            </a:prstGeom>
          </p:spPr>
        </p:pic>
      </p:grpSp>
      <p:sp>
        <p:nvSpPr>
          <p:cNvPr id="8" name="Rectángulo 7"/>
          <p:cNvSpPr/>
          <p:nvPr/>
        </p:nvSpPr>
        <p:spPr>
          <a:xfrm>
            <a:off x="-8381" y="8774668"/>
            <a:ext cx="199317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ea typeface="Calibri" charset="0"/>
                <a:cs typeface="Times New Roman" charset="0"/>
              </a:rPr>
              <a:t>Supplementary Figure 9</a:t>
            </a:r>
            <a:r>
              <a:rPr lang="es-ES_tradnl" sz="1400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0508528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33</TotalTime>
  <Words>64</Words>
  <Application>Microsoft Macintosh PowerPoint</Application>
  <PresentationFormat>Carta (216 x 279 mm)</PresentationFormat>
  <Paragraphs>33</Paragraphs>
  <Slides>3</Slides>
  <Notes>2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8" baseType="lpstr">
      <vt:lpstr>Calibri</vt:lpstr>
      <vt:lpstr>Calibri Light</vt:lpstr>
      <vt:lpstr>Times New Roman</vt:lpstr>
      <vt:lpstr>Arial</vt:lpstr>
      <vt:lpstr>Office Theme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5.003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vier Gil Humanes</dc:creator>
  <cp:lastModifiedBy>Francisco Barro</cp:lastModifiedBy>
  <cp:revision>19</cp:revision>
  <dcterms:created xsi:type="dcterms:W3CDTF">2016-10-13T13:26:43Z</dcterms:created>
  <dcterms:modified xsi:type="dcterms:W3CDTF">2017-08-01T08:28:20Z</dcterms:modified>
</cp:coreProperties>
</file>